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4" autoAdjust="0"/>
    <p:restoredTop sz="94660"/>
  </p:normalViewPr>
  <p:slideViewPr>
    <p:cSldViewPr snapToGrid="0">
      <p:cViewPr>
        <p:scale>
          <a:sx n="150" d="100"/>
          <a:sy n="150" d="100"/>
        </p:scale>
        <p:origin x="182" y="-25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\Documents\Write-ups\_Manuscripts\ABA%20suppresses%20WGE%20elicitation%20of%20glyceollins\Extras\Fig2\Hormones%20Abiotic%20Stress%20Time%20Course%20Soy%20Jan12%2017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\Documents\Write-ups\_Manuscripts\ABA%20suppresses%20WGE%20elicitation%20of%20glyceollins\Extras\Fig2\Hormones%20Abiotic%20Stress%20Time%20Course%20Soy%20Jan12%2017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min\Documents\Write-ups\_Manuscripts\ABA%20suppresses%20WGE%20elicitation%20of%20glyceollins\Extras\Fig2\Hormones%20Abiotic%20Stress%20Time%20Course%20Soy%20Jan12%2017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2712462616715748"/>
          <c:y val="0.1284300939053325"/>
          <c:w val="0.47628975184348099"/>
          <c:h val="0.29743533078290407"/>
        </c:manualLayout>
      </c:layout>
      <c:barChart>
        <c:barDir val="col"/>
        <c:grouping val="clustered"/>
        <c:varyColors val="0"/>
        <c:ser>
          <c:idx val="0"/>
          <c:order val="0"/>
          <c:tx>
            <c:v>ABA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BA!$S$20:$S$23</c:f>
                <c:numCache>
                  <c:formatCode>General</c:formatCode>
                  <c:ptCount val="4"/>
                  <c:pt idx="0">
                    <c:v>6.6798878756717583E-2</c:v>
                  </c:pt>
                  <c:pt idx="1">
                    <c:v>0.77093915589785367</c:v>
                  </c:pt>
                  <c:pt idx="2">
                    <c:v>0.22949825268563723</c:v>
                  </c:pt>
                  <c:pt idx="3">
                    <c:v>0.20788501822025296</c:v>
                  </c:pt>
                </c:numCache>
              </c:numRef>
            </c:plus>
            <c:minus>
              <c:numRef>
                <c:f>ABA!$S$20:$S$23</c:f>
                <c:numCache>
                  <c:formatCode>General</c:formatCode>
                  <c:ptCount val="4"/>
                  <c:pt idx="0">
                    <c:v>6.6798878756717583E-2</c:v>
                  </c:pt>
                  <c:pt idx="1">
                    <c:v>0.77093915589785367</c:v>
                  </c:pt>
                  <c:pt idx="2">
                    <c:v>0.22949825268563723</c:v>
                  </c:pt>
                  <c:pt idx="3">
                    <c:v>0.2078850182202529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2]ABA!$O$16:$O$19</c:f>
              <c:strCache>
                <c:ptCount val="4"/>
                <c:pt idx="0">
                  <c:v>Control 6 dat</c:v>
                </c:pt>
                <c:pt idx="1">
                  <c:v>Dehydration 6 dat</c:v>
                </c:pt>
                <c:pt idx="2">
                  <c:v>Control 9 dat</c:v>
                </c:pt>
                <c:pt idx="3">
                  <c:v>pH 3.0 9 dat</c:v>
                </c:pt>
              </c:strCache>
            </c:strRef>
          </c:cat>
          <c:val>
            <c:numRef>
              <c:f>ABA!$R$20:$R$23</c:f>
              <c:numCache>
                <c:formatCode>General</c:formatCode>
                <c:ptCount val="4"/>
                <c:pt idx="0">
                  <c:v>0.60876385849565562</c:v>
                </c:pt>
                <c:pt idx="1">
                  <c:v>1.8830823470326721</c:v>
                </c:pt>
                <c:pt idx="2">
                  <c:v>0.65312381404821718</c:v>
                </c:pt>
                <c:pt idx="3">
                  <c:v>0.695406514028203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A2-4DCA-95A0-05AF26B1E9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5"/>
        <c:overlap val="-25"/>
        <c:axId val="511966552"/>
        <c:axId val="511966944"/>
      </c:barChart>
      <c:catAx>
        <c:axId val="511966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AR PL UKai TW MBE" panose="02000503000000000000" pitchFamily="2" charset="-128"/>
                <a:cs typeface="Arial" panose="020B0604020202020204" pitchFamily="34" charset="0"/>
              </a:defRPr>
            </a:pPr>
            <a:endParaRPr lang="en-US"/>
          </a:p>
        </c:txPr>
        <c:crossAx val="511966944"/>
        <c:crosses val="autoZero"/>
        <c:auto val="1"/>
        <c:lblAlgn val="ctr"/>
        <c:lblOffset val="0"/>
        <c:noMultiLvlLbl val="0"/>
      </c:catAx>
      <c:valAx>
        <c:axId val="511966944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800" b="0" i="0" u="none" strike="noStrike" kern="1200" baseline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  <a:ea typeface="AR PL UKai TW MBE" panose="02000503000000000000" pitchFamily="2" charset="-128"/>
                    <a:cs typeface="Arial" panose="020B0604020202020204" pitchFamily="34" charset="0"/>
                  </a:defRPr>
                </a:pPr>
                <a:r>
                  <a:rPr lang="en-US"/>
                  <a:t>Amount  (µg g-1)</a:t>
                </a:r>
              </a:p>
              <a:p>
                <a:pPr algn="ctr" rtl="0">
                  <a:defRPr/>
                </a:pP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800" b="0" i="0" u="none" strike="noStrike" kern="1200" baseline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ea typeface="AR PL UKai TW MBE" panose="02000503000000000000" pitchFamily="2" charset="-128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AR PL UKai TW MBE" panose="02000503000000000000" pitchFamily="2" charset="-128"/>
                <a:cs typeface="Arial" panose="020B0604020202020204" pitchFamily="34" charset="0"/>
              </a:defRPr>
            </a:pPr>
            <a:endParaRPr lang="en-US"/>
          </a:p>
        </c:txPr>
        <c:crossAx val="511966552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>
              <a:lumMod val="95000"/>
              <a:lumOff val="5000"/>
            </a:schemeClr>
          </a:solidFill>
          <a:latin typeface="Arial" panose="020B0604020202020204" pitchFamily="34" charset="0"/>
          <a:ea typeface="AR PL UKai TW MBE" panose="02000503000000000000" pitchFamily="2" charset="-128"/>
          <a:cs typeface="Arial" panose="020B0604020202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9182374666450298"/>
          <c:y val="3.3871506414206595E-2"/>
          <c:w val="0.51542289892666238"/>
          <c:h val="0.54568369519955939"/>
        </c:manualLayout>
      </c:layout>
      <c:barChart>
        <c:barDir val="col"/>
        <c:grouping val="clustered"/>
        <c:varyColors val="0"/>
        <c:ser>
          <c:idx val="0"/>
          <c:order val="0"/>
          <c:tx>
            <c:v>ABA-GE this experiment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ABA-GE'!$R$19:$R$22</c:f>
                <c:numCache>
                  <c:formatCode>General</c:formatCode>
                  <c:ptCount val="4"/>
                  <c:pt idx="0">
                    <c:v>5.9393507460729307</c:v>
                  </c:pt>
                  <c:pt idx="1">
                    <c:v>4.9230120298580413</c:v>
                  </c:pt>
                  <c:pt idx="2">
                    <c:v>1.7943088969803211</c:v>
                  </c:pt>
                  <c:pt idx="3">
                    <c:v>11.278532262199599</c:v>
                  </c:pt>
                </c:numCache>
              </c:numRef>
            </c:plus>
            <c:minus>
              <c:numRef>
                <c:f>'ABA-GE'!$R$19:$R$22</c:f>
                <c:numCache>
                  <c:formatCode>General</c:formatCode>
                  <c:ptCount val="4"/>
                  <c:pt idx="0">
                    <c:v>5.9393507460729307</c:v>
                  </c:pt>
                  <c:pt idx="1">
                    <c:v>4.9230120298580413</c:v>
                  </c:pt>
                  <c:pt idx="2">
                    <c:v>1.7943088969803211</c:v>
                  </c:pt>
                  <c:pt idx="3">
                    <c:v>11.278532262199599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2]ABA!$O$16:$O$19</c:f>
              <c:strCache>
                <c:ptCount val="4"/>
                <c:pt idx="0">
                  <c:v>Control 6 dat</c:v>
                </c:pt>
                <c:pt idx="1">
                  <c:v>Dehydration 6 dat</c:v>
                </c:pt>
                <c:pt idx="2">
                  <c:v>Control 9 dat</c:v>
                </c:pt>
                <c:pt idx="3">
                  <c:v>pH 3.0 9 dat</c:v>
                </c:pt>
              </c:strCache>
            </c:strRef>
          </c:cat>
          <c:val>
            <c:numRef>
              <c:f>'ABA-GE'!$Q$19:$Q$22</c:f>
              <c:numCache>
                <c:formatCode>General</c:formatCode>
                <c:ptCount val="4"/>
                <c:pt idx="0">
                  <c:v>20.54823902174844</c:v>
                </c:pt>
                <c:pt idx="1">
                  <c:v>13.820776287224476</c:v>
                </c:pt>
                <c:pt idx="2">
                  <c:v>8.6056381907945632</c:v>
                </c:pt>
                <c:pt idx="3">
                  <c:v>70.4095070167886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91C-458F-9F84-F9F4644B2B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5"/>
        <c:overlap val="-25"/>
        <c:axId val="340100432"/>
        <c:axId val="340100040"/>
      </c:barChart>
      <c:catAx>
        <c:axId val="3401004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0100040"/>
        <c:crosses val="autoZero"/>
        <c:auto val="1"/>
        <c:lblAlgn val="ctr"/>
        <c:lblOffset val="0"/>
        <c:noMultiLvlLbl val="0"/>
      </c:catAx>
      <c:valAx>
        <c:axId val="340100040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0100432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7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0" i="0" u="none" strike="noStrike" kern="1200" spc="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 dirty="0"/>
              <a:t>JA</a:t>
            </a:r>
          </a:p>
        </c:rich>
      </c:tx>
      <c:layout>
        <c:manualLayout>
          <c:xMode val="edge"/>
          <c:yMode val="edge"/>
          <c:x val="0.51515087991447173"/>
          <c:y val="7.396191677669636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spc="0" baseline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2712462616715748"/>
          <c:y val="0.1284300939053325"/>
          <c:w val="0.47628975184348099"/>
          <c:h val="0.2974353307829040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4472C4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4472C4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E0D-4E66-AAA4-E3DC6B938887}"/>
              </c:ext>
            </c:extLst>
          </c:dPt>
          <c:dPt>
            <c:idx val="1"/>
            <c:invertIfNegative val="0"/>
            <c:bubble3D val="0"/>
            <c:spPr>
              <a:solidFill>
                <a:srgbClr val="4472C4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E0D-4E66-AAA4-E3DC6B938887}"/>
              </c:ext>
            </c:extLst>
          </c:dPt>
          <c:dPt>
            <c:idx val="2"/>
            <c:invertIfNegative val="0"/>
            <c:bubble3D val="0"/>
            <c:spPr>
              <a:solidFill>
                <a:srgbClr val="4472C4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E0D-4E66-AAA4-E3DC6B938887}"/>
              </c:ext>
            </c:extLst>
          </c:dPt>
          <c:dPt>
            <c:idx val="3"/>
            <c:invertIfNegative val="0"/>
            <c:bubble3D val="0"/>
            <c:spPr>
              <a:solidFill>
                <a:srgbClr val="4472C4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7E0D-4E66-AAA4-E3DC6B938887}"/>
              </c:ext>
            </c:extLst>
          </c:dPt>
          <c:errBars>
            <c:errBarType val="both"/>
            <c:errValType val="cust"/>
            <c:noEndCap val="0"/>
            <c:plus>
              <c:numRef>
                <c:f>JA!$O$29:$O$32</c:f>
                <c:numCache>
                  <c:formatCode>General</c:formatCode>
                  <c:ptCount val="4"/>
                  <c:pt idx="0">
                    <c:v>0.23155275185607505</c:v>
                  </c:pt>
                  <c:pt idx="1">
                    <c:v>0.22242958522198972</c:v>
                  </c:pt>
                  <c:pt idx="2">
                    <c:v>0.43120166090970452</c:v>
                  </c:pt>
                  <c:pt idx="3">
                    <c:v>0.66318206046609562</c:v>
                  </c:pt>
                </c:numCache>
              </c:numRef>
            </c:plus>
            <c:minus>
              <c:numRef>
                <c:f>JA!$O$29:$O$32</c:f>
                <c:numCache>
                  <c:formatCode>General</c:formatCode>
                  <c:ptCount val="4"/>
                  <c:pt idx="0">
                    <c:v>0.23155275185607505</c:v>
                  </c:pt>
                  <c:pt idx="1">
                    <c:v>0.22242958522198972</c:v>
                  </c:pt>
                  <c:pt idx="2">
                    <c:v>0.43120166090970452</c:v>
                  </c:pt>
                  <c:pt idx="3">
                    <c:v>0.6631820604660956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2]ABA!$O$16:$O$19</c:f>
              <c:strCache>
                <c:ptCount val="4"/>
                <c:pt idx="0">
                  <c:v>Control 6 dat</c:v>
                </c:pt>
                <c:pt idx="1">
                  <c:v>Dehydration 6 dat</c:v>
                </c:pt>
                <c:pt idx="2">
                  <c:v>Control 9 dat</c:v>
                </c:pt>
                <c:pt idx="3">
                  <c:v>pH 3.0 9 dat</c:v>
                </c:pt>
              </c:strCache>
            </c:strRef>
          </c:cat>
          <c:val>
            <c:numRef>
              <c:f>JA!$N$29:$N$32</c:f>
              <c:numCache>
                <c:formatCode>0</c:formatCode>
                <c:ptCount val="4"/>
                <c:pt idx="0">
                  <c:v>1.3416659857982292</c:v>
                </c:pt>
                <c:pt idx="1">
                  <c:v>0.40284703586338649</c:v>
                </c:pt>
                <c:pt idx="2">
                  <c:v>2.0806651505199998</c:v>
                </c:pt>
                <c:pt idx="3">
                  <c:v>3.3327048315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E0D-4E66-AAA4-E3DC6B9388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5"/>
        <c:overlap val="-25"/>
        <c:axId val="511966552"/>
        <c:axId val="511966944"/>
      </c:barChart>
      <c:catAx>
        <c:axId val="5119665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11966944"/>
        <c:crosses val="autoZero"/>
        <c:auto val="1"/>
        <c:lblAlgn val="ctr"/>
        <c:lblOffset val="0"/>
        <c:noMultiLvlLbl val="0"/>
      </c:catAx>
      <c:valAx>
        <c:axId val="511966944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bg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>
                    <a:solidFill>
                      <a:schemeClr val="bg1"/>
                    </a:solidFill>
                  </a:rPr>
                  <a:t>Amount (µg g-1 DW)</a:t>
                </a:r>
              </a:p>
            </c:rich>
          </c:tx>
          <c:layout>
            <c:manualLayout>
              <c:xMode val="edge"/>
              <c:yMode val="edge"/>
              <c:x val="1.2472118194951304E-2"/>
              <c:y val="6.831313680444732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bg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11966552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>
          <a:solidFill>
            <a:schemeClr val="tx1">
              <a:lumMod val="95000"/>
              <a:lumOff val="5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9647</cdr:x>
      <cdr:y>0.26804</cdr:y>
    </cdr:from>
    <cdr:to>
      <cdr:x>0.94169</cdr:x>
      <cdr:y>0.338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0A949831-72A1-43E7-814A-B0DF8509AD07}"/>
            </a:ext>
          </a:extLst>
        </cdr:cNvPr>
        <cdr:cNvSpPr txBox="1"/>
      </cdr:nvSpPr>
      <cdr:spPr>
        <a:xfrm xmlns:a="http://schemas.openxmlformats.org/drawingml/2006/main">
          <a:off x="835876" y="1294742"/>
          <a:ext cx="152405" cy="3379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100"/>
            <a:t>b</a:t>
          </a:r>
        </a:p>
      </cdr:txBody>
    </cdr:sp>
  </cdr:relSizeAnchor>
  <cdr:relSizeAnchor xmlns:cdr="http://schemas.openxmlformats.org/drawingml/2006/chartDrawing">
    <cdr:from>
      <cdr:x>0.48942</cdr:x>
      <cdr:y>0.10805</cdr:y>
    </cdr:from>
    <cdr:to>
      <cdr:x>0.63463</cdr:x>
      <cdr:y>0.178</cdr:y>
    </cdr:to>
    <cdr:sp macro="" textlink="">
      <cdr:nvSpPr>
        <cdr:cNvPr id="3" name="TextBox 1">
          <a:extLst xmlns:a="http://schemas.openxmlformats.org/drawingml/2006/main">
            <a:ext uri="{FF2B5EF4-FFF2-40B4-BE49-F238E27FC236}">
              <a16:creationId xmlns:a16="http://schemas.microsoft.com/office/drawing/2014/main" id="{4432CCC9-6844-419D-89AF-66975D4494CF}"/>
            </a:ext>
          </a:extLst>
        </cdr:cNvPr>
        <cdr:cNvSpPr txBox="1"/>
      </cdr:nvSpPr>
      <cdr:spPr>
        <a:xfrm xmlns:a="http://schemas.openxmlformats.org/drawingml/2006/main">
          <a:off x="513634" y="521936"/>
          <a:ext cx="152395" cy="33788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100" dirty="0"/>
            <a:t>a</a:t>
          </a:r>
        </a:p>
      </cdr:txBody>
    </cdr:sp>
  </cdr:relSizeAnchor>
  <cdr:relSizeAnchor xmlns:cdr="http://schemas.openxmlformats.org/drawingml/2006/chartDrawing">
    <cdr:from>
      <cdr:x>0.64095</cdr:x>
      <cdr:y>0.27019</cdr:y>
    </cdr:from>
    <cdr:to>
      <cdr:x>0.78616</cdr:x>
      <cdr:y>0.34015</cdr:y>
    </cdr:to>
    <cdr:sp macro="" textlink="">
      <cdr:nvSpPr>
        <cdr:cNvPr id="4" name="TextBox 1">
          <a:extLst xmlns:a="http://schemas.openxmlformats.org/drawingml/2006/main">
            <a:ext uri="{FF2B5EF4-FFF2-40B4-BE49-F238E27FC236}">
              <a16:creationId xmlns:a16="http://schemas.microsoft.com/office/drawing/2014/main" id="{82FC30AB-0E3B-4307-8835-E84354EF0363}"/>
            </a:ext>
          </a:extLst>
        </cdr:cNvPr>
        <cdr:cNvSpPr txBox="1"/>
      </cdr:nvSpPr>
      <cdr:spPr>
        <a:xfrm xmlns:a="http://schemas.openxmlformats.org/drawingml/2006/main">
          <a:off x="672661" y="1305099"/>
          <a:ext cx="152395" cy="3379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100"/>
            <a:t>b</a:t>
          </a:r>
        </a:p>
      </cdr:txBody>
    </cdr:sp>
  </cdr:relSizeAnchor>
  <cdr:relSizeAnchor xmlns:cdr="http://schemas.openxmlformats.org/drawingml/2006/chartDrawing">
    <cdr:from>
      <cdr:x>0.31989</cdr:x>
      <cdr:y>0.2872</cdr:y>
    </cdr:from>
    <cdr:to>
      <cdr:x>0.52593</cdr:x>
      <cdr:y>0.35716</cdr:y>
    </cdr:to>
    <cdr:sp macro="" textlink="">
      <cdr:nvSpPr>
        <cdr:cNvPr id="5" name="TextBox 1">
          <a:extLst xmlns:a="http://schemas.openxmlformats.org/drawingml/2006/main">
            <a:ext uri="{FF2B5EF4-FFF2-40B4-BE49-F238E27FC236}">
              <a16:creationId xmlns:a16="http://schemas.microsoft.com/office/drawing/2014/main" id="{29473729-CC45-44CB-AC53-23EC22C3DB93}"/>
            </a:ext>
          </a:extLst>
        </cdr:cNvPr>
        <cdr:cNvSpPr txBox="1"/>
      </cdr:nvSpPr>
      <cdr:spPr>
        <a:xfrm xmlns:a="http://schemas.openxmlformats.org/drawingml/2006/main">
          <a:off x="335717" y="1387263"/>
          <a:ext cx="216234" cy="3379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100"/>
            <a:t>b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80373</cdr:x>
      <cdr:y>0.12291</cdr:y>
    </cdr:from>
    <cdr:to>
      <cdr:x>0.94895</cdr:x>
      <cdr:y>0.19287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0A949831-72A1-43E7-814A-B0DF8509AD07}"/>
            </a:ext>
          </a:extLst>
        </cdr:cNvPr>
        <cdr:cNvSpPr txBox="1"/>
      </cdr:nvSpPr>
      <cdr:spPr>
        <a:xfrm xmlns:a="http://schemas.openxmlformats.org/drawingml/2006/main">
          <a:off x="843498" y="593698"/>
          <a:ext cx="152401" cy="3379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100"/>
            <a:t>a</a:t>
          </a:r>
        </a:p>
      </cdr:txBody>
    </cdr:sp>
  </cdr:relSizeAnchor>
  <cdr:relSizeAnchor xmlns:cdr="http://schemas.openxmlformats.org/drawingml/2006/chartDrawing">
    <cdr:from>
      <cdr:x>0.49668</cdr:x>
      <cdr:y>0.30682</cdr:y>
    </cdr:from>
    <cdr:to>
      <cdr:x>0.64189</cdr:x>
      <cdr:y>0.37677</cdr:y>
    </cdr:to>
    <cdr:sp macro="" textlink="">
      <cdr:nvSpPr>
        <cdr:cNvPr id="3" name="TextBox 1">
          <a:extLst xmlns:a="http://schemas.openxmlformats.org/drawingml/2006/main">
            <a:ext uri="{FF2B5EF4-FFF2-40B4-BE49-F238E27FC236}">
              <a16:creationId xmlns:a16="http://schemas.microsoft.com/office/drawing/2014/main" id="{4432CCC9-6844-419D-89AF-66975D4494CF}"/>
            </a:ext>
          </a:extLst>
        </cdr:cNvPr>
        <cdr:cNvSpPr txBox="1"/>
      </cdr:nvSpPr>
      <cdr:spPr>
        <a:xfrm xmlns:a="http://schemas.openxmlformats.org/drawingml/2006/main">
          <a:off x="521252" y="1482034"/>
          <a:ext cx="152401" cy="3379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100"/>
            <a:t>c</a:t>
          </a:r>
        </a:p>
      </cdr:txBody>
    </cdr:sp>
  </cdr:relSizeAnchor>
  <cdr:relSizeAnchor xmlns:cdr="http://schemas.openxmlformats.org/drawingml/2006/chartDrawing">
    <cdr:from>
      <cdr:x>0.64821</cdr:x>
      <cdr:y>0.20393</cdr:y>
    </cdr:from>
    <cdr:to>
      <cdr:x>0.79342</cdr:x>
      <cdr:y>0.27389</cdr:y>
    </cdr:to>
    <cdr:sp macro="" textlink="">
      <cdr:nvSpPr>
        <cdr:cNvPr id="4" name="TextBox 1">
          <a:extLst xmlns:a="http://schemas.openxmlformats.org/drawingml/2006/main">
            <a:ext uri="{FF2B5EF4-FFF2-40B4-BE49-F238E27FC236}">
              <a16:creationId xmlns:a16="http://schemas.microsoft.com/office/drawing/2014/main" id="{82FC30AB-0E3B-4307-8835-E84354EF0363}"/>
            </a:ext>
          </a:extLst>
        </cdr:cNvPr>
        <cdr:cNvSpPr txBox="1"/>
      </cdr:nvSpPr>
      <cdr:spPr>
        <a:xfrm xmlns:a="http://schemas.openxmlformats.org/drawingml/2006/main">
          <a:off x="680278" y="985078"/>
          <a:ext cx="152401" cy="33793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100"/>
            <a:t>b</a:t>
          </a:r>
        </a:p>
      </cdr:txBody>
    </cdr:sp>
  </cdr:relSizeAnchor>
  <cdr:relSizeAnchor xmlns:cdr="http://schemas.openxmlformats.org/drawingml/2006/chartDrawing">
    <cdr:from>
      <cdr:x>0.25636</cdr:x>
      <cdr:y>0.24974</cdr:y>
    </cdr:from>
    <cdr:to>
      <cdr:x>0.58168</cdr:x>
      <cdr:y>0.31042</cdr:y>
    </cdr:to>
    <cdr:sp macro="" textlink="">
      <cdr:nvSpPr>
        <cdr:cNvPr id="5" name="TextBox 1">
          <a:extLst xmlns:a="http://schemas.openxmlformats.org/drawingml/2006/main">
            <a:ext uri="{FF2B5EF4-FFF2-40B4-BE49-F238E27FC236}">
              <a16:creationId xmlns:a16="http://schemas.microsoft.com/office/drawing/2014/main" id="{29473729-CC45-44CB-AC53-23EC22C3DB93}"/>
            </a:ext>
          </a:extLst>
        </cdr:cNvPr>
        <cdr:cNvSpPr txBox="1"/>
      </cdr:nvSpPr>
      <cdr:spPr>
        <a:xfrm xmlns:a="http://schemas.openxmlformats.org/drawingml/2006/main">
          <a:off x="269041" y="1057532"/>
          <a:ext cx="341423" cy="2569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100" dirty="0" err="1"/>
            <a:t>bc</a:t>
          </a:r>
          <a:endParaRPr lang="en-US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D7E4C-6222-4BDA-843B-9B160AC9B443}" type="datetimeFigureOut">
              <a:rPr lang="en-US" smtClean="0"/>
              <a:t>9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9D601-8057-4794-BF7F-A24606FE31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9204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D7E4C-6222-4BDA-843B-9B160AC9B443}" type="datetimeFigureOut">
              <a:rPr lang="en-US" smtClean="0"/>
              <a:t>9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9D601-8057-4794-BF7F-A24606FE31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080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D7E4C-6222-4BDA-843B-9B160AC9B443}" type="datetimeFigureOut">
              <a:rPr lang="en-US" smtClean="0"/>
              <a:t>9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9D601-8057-4794-BF7F-A24606FE31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744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D7E4C-6222-4BDA-843B-9B160AC9B443}" type="datetimeFigureOut">
              <a:rPr lang="en-US" smtClean="0"/>
              <a:t>9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9D601-8057-4794-BF7F-A24606FE31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647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D7E4C-6222-4BDA-843B-9B160AC9B443}" type="datetimeFigureOut">
              <a:rPr lang="en-US" smtClean="0"/>
              <a:t>9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9D601-8057-4794-BF7F-A24606FE31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585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D7E4C-6222-4BDA-843B-9B160AC9B443}" type="datetimeFigureOut">
              <a:rPr lang="en-US" smtClean="0"/>
              <a:t>9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9D601-8057-4794-BF7F-A24606FE31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504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D7E4C-6222-4BDA-843B-9B160AC9B443}" type="datetimeFigureOut">
              <a:rPr lang="en-US" smtClean="0"/>
              <a:t>9/1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9D601-8057-4794-BF7F-A24606FE31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398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D7E4C-6222-4BDA-843B-9B160AC9B443}" type="datetimeFigureOut">
              <a:rPr lang="en-US" smtClean="0"/>
              <a:t>9/1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9D601-8057-4794-BF7F-A24606FE31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126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D7E4C-6222-4BDA-843B-9B160AC9B443}" type="datetimeFigureOut">
              <a:rPr lang="en-US" smtClean="0"/>
              <a:t>9/1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9D601-8057-4794-BF7F-A24606FE31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92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D7E4C-6222-4BDA-843B-9B160AC9B443}" type="datetimeFigureOut">
              <a:rPr lang="en-US" smtClean="0"/>
              <a:t>9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9D601-8057-4794-BF7F-A24606FE31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9935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7D7E4C-6222-4BDA-843B-9B160AC9B443}" type="datetimeFigureOut">
              <a:rPr lang="en-US" smtClean="0"/>
              <a:t>9/1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9D601-8057-4794-BF7F-A24606FE31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172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7D7E4C-6222-4BDA-843B-9B160AC9B443}" type="datetimeFigureOut">
              <a:rPr lang="en-US" smtClean="0"/>
              <a:t>9/1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49D601-8057-4794-BF7F-A24606FE31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60717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Chart 14">
            <a:extLst>
              <a:ext uri="{FF2B5EF4-FFF2-40B4-BE49-F238E27FC236}">
                <a16:creationId xmlns:a16="http://schemas.microsoft.com/office/drawing/2014/main" id="{5561717B-EA26-47D8-AB0B-C3956987B13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53849657"/>
              </p:ext>
            </p:extLst>
          </p:nvPr>
        </p:nvGraphicFramePr>
        <p:xfrm>
          <a:off x="2186377" y="2196608"/>
          <a:ext cx="1049477" cy="48303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6" name="Group 15">
            <a:extLst>
              <a:ext uri="{FF2B5EF4-FFF2-40B4-BE49-F238E27FC236}">
                <a16:creationId xmlns:a16="http://schemas.microsoft.com/office/drawing/2014/main" id="{4E64CC14-42E2-4A7A-8739-7196EA3E1548}"/>
              </a:ext>
            </a:extLst>
          </p:cNvPr>
          <p:cNvGrpSpPr/>
          <p:nvPr/>
        </p:nvGrpSpPr>
        <p:grpSpPr>
          <a:xfrm>
            <a:off x="3186614" y="2976972"/>
            <a:ext cx="1226469" cy="1935614"/>
            <a:chOff x="4701089" y="2355649"/>
            <a:chExt cx="1226469" cy="1935614"/>
          </a:xfrm>
        </p:grpSpPr>
        <p:graphicFrame>
          <p:nvGraphicFramePr>
            <p:cNvPr id="17" name="Chart 16">
              <a:extLst>
                <a:ext uri="{FF2B5EF4-FFF2-40B4-BE49-F238E27FC236}">
                  <a16:creationId xmlns:a16="http://schemas.microsoft.com/office/drawing/2014/main" id="{C6664710-9BB0-4230-886C-FD5F1420708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69180119"/>
                </p:ext>
              </p:extLst>
            </p:nvPr>
          </p:nvGraphicFramePr>
          <p:xfrm>
            <a:off x="4701089" y="2355649"/>
            <a:ext cx="1226469" cy="193561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84B74D4-8BB7-4EC4-99BC-DD0F3AC84A11}"/>
                </a:ext>
              </a:extLst>
            </p:cNvPr>
            <p:cNvSpPr txBox="1"/>
            <p:nvPr/>
          </p:nvSpPr>
          <p:spPr>
            <a:xfrm>
              <a:off x="5610225" y="2371725"/>
              <a:ext cx="2571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C3A2225-4F3E-4EC1-A7ED-F75AEFB6C7FF}"/>
                </a:ext>
              </a:extLst>
            </p:cNvPr>
            <p:cNvSpPr txBox="1"/>
            <p:nvPr/>
          </p:nvSpPr>
          <p:spPr>
            <a:xfrm>
              <a:off x="5143500" y="2990850"/>
              <a:ext cx="2571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CB4901F-2760-49E4-9CF5-76FDEEAE3190}"/>
                </a:ext>
              </a:extLst>
            </p:cNvPr>
            <p:cNvSpPr txBox="1"/>
            <p:nvPr/>
          </p:nvSpPr>
          <p:spPr>
            <a:xfrm>
              <a:off x="5295900" y="3105150"/>
              <a:ext cx="2571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BF1B05D-F482-48D2-9FB1-1B8BAB885F24}"/>
                </a:ext>
              </a:extLst>
            </p:cNvPr>
            <p:cNvSpPr txBox="1"/>
            <p:nvPr/>
          </p:nvSpPr>
          <p:spPr>
            <a:xfrm>
              <a:off x="5448300" y="3181350"/>
              <a:ext cx="2571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graphicFrame>
        <p:nvGraphicFramePr>
          <p:cNvPr id="22" name="Chart 21">
            <a:extLst>
              <a:ext uri="{FF2B5EF4-FFF2-40B4-BE49-F238E27FC236}">
                <a16:creationId xmlns:a16="http://schemas.microsoft.com/office/drawing/2014/main" id="{11B3BDE4-817A-4892-BE2B-22BED4F4E6C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37689039"/>
              </p:ext>
            </p:extLst>
          </p:nvPr>
        </p:nvGraphicFramePr>
        <p:xfrm>
          <a:off x="4267098" y="2413165"/>
          <a:ext cx="1049477" cy="42344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3" name="TextBox 22">
            <a:extLst>
              <a:ext uri="{FF2B5EF4-FFF2-40B4-BE49-F238E27FC236}">
                <a16:creationId xmlns:a16="http://schemas.microsoft.com/office/drawing/2014/main" id="{566F3783-94F0-49B4-A52E-2A0273AA74EE}"/>
              </a:ext>
            </a:extLst>
          </p:cNvPr>
          <p:cNvSpPr txBox="1"/>
          <p:nvPr/>
        </p:nvSpPr>
        <p:spPr>
          <a:xfrm>
            <a:off x="3705225" y="2716823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BA-GE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76D1AFC-1AE6-4584-A2BE-A8046067C208}"/>
              </a:ext>
            </a:extLst>
          </p:cNvPr>
          <p:cNvSpPr txBox="1"/>
          <p:nvPr/>
        </p:nvSpPr>
        <p:spPr>
          <a:xfrm>
            <a:off x="2790825" y="2726348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BA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D5DE90AA-7BF2-42ED-97BF-D73A10F2C2F5}"/>
              </a:ext>
            </a:extLst>
          </p:cNvPr>
          <p:cNvSpPr/>
          <p:nvPr/>
        </p:nvSpPr>
        <p:spPr>
          <a:xfrm>
            <a:off x="1877099" y="4904192"/>
            <a:ext cx="3886200" cy="830997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. </a:t>
            </a: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eat of experiment shown in Figure 2D - ABA, ABA-GE, and JA amounts in </a:t>
            </a:r>
            <a:r>
              <a:rPr lang="en-US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arosoy</a:t>
            </a: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63 seedlings after 6 d dehydration and 9 d acidy stress measured by UPLC-</a:t>
            </a:r>
            <a:r>
              <a:rPr lang="en-US" sz="8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S</a:t>
            </a:r>
            <a:r>
              <a:rPr lang="en-US" sz="800" baseline="30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</a:t>
            </a:r>
            <a:r>
              <a:rPr lang="en-US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altLang="zh-CN" sz="8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ferent letters show significant differences by single factor ANOVA, Tukey post hoc test, </a:t>
            </a:r>
            <a:r>
              <a:rPr lang="en-US" altLang="zh-CN" sz="800" i="1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8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lt; 0.05, </a:t>
            </a:r>
            <a:r>
              <a:rPr lang="el-GR" altLang="zh-CN" sz="800" kern="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 = 0.05. </a:t>
            </a:r>
            <a:r>
              <a:rPr lang="en-US" altLang="zh-CN" sz="800" kern="100" dirty="0">
                <a:latin typeface="Arial" panose="020B0604020202020204" pitchFamily="34" charset="0"/>
                <a:cs typeface="Arial" panose="020B0604020202020204" pitchFamily="34" charset="0"/>
              </a:rPr>
              <a:t>Error bars = standard error (SE) for  3-5 biological duplicates. For a list of statistical values, see Supplementary Table S1.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97415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109</Words>
  <Application>Microsoft Office PowerPoint</Application>
  <PresentationFormat>Custom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 PL UKai TW MBE</vt:lpstr>
      <vt:lpstr>等线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Nik Kovinich</cp:lastModifiedBy>
  <cp:revision>5</cp:revision>
  <dcterms:created xsi:type="dcterms:W3CDTF">2023-08-22T23:19:45Z</dcterms:created>
  <dcterms:modified xsi:type="dcterms:W3CDTF">2024-09-18T01:17:46Z</dcterms:modified>
</cp:coreProperties>
</file>